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264" y="10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A9269-8F9D-8C43-E44E-E62106E15B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66FA6E-0FD5-E372-0625-834D20FBDB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664A8-3DC8-D5B0-82CA-44ACBBB5E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38943-4AAF-06DB-13EF-7F40BA7B6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AD2FB3-35BC-4558-FB5B-42108A22A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2772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67818-17C8-B62D-1184-26FDFB54DF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F511CE-53D1-B95E-BCAB-836EC1A2AD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9B1CC-5B1A-B8B9-8B20-AB79B5F4E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70FC3B-35D1-5039-B74C-1768FCF8B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0B06BB-F2AE-054A-1CCB-1BB07320A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688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6248FE-095F-1047-2CE7-763D54E784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71FC49-5183-379B-11EF-56C00A8F0E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2FEF7C-6C03-90EE-511F-E3E9EDD33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E4232D-B970-9079-F6FF-7349887A1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4FCE62-55A0-8952-4DFA-BB043E906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58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AE7F6-5EA1-4259-D71B-A4E516461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30C40E-EFBC-2C10-57B4-11EC8CFA80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9EDA2-1BE8-FD33-2EBE-1FA376351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37C975-E341-9C59-C434-643BD3EC9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0BE37B-6547-02FE-2465-4A943DBDA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730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AEB48A-F0DB-A171-9AA7-7D1B84E4E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DB5DA0-A1C4-A314-DE8F-75DEC185E8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9D7094-A52F-7C4E-30F9-624F1332F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35221C-A66A-6BB6-EB7F-3628E5503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D1067-A7C9-23E1-38B2-686F9B441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4867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05029-CF9D-7412-1FD5-88D9B6B66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A7BADE-1111-1326-3FF6-F6463F18BB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C17953-B9B2-DC35-638C-57272105F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6486CA-C145-F600-C6C0-23F4C6B4A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856898-9BC1-07D9-08DD-6CB52124C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ED4A0D-830D-2B6B-519E-001A827EC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1966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4AEAF-9417-40DB-34E3-5DBB0083B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2FE445-7174-E2A2-3137-2ED06EEC69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495B8C-B3AF-8747-14DA-9DEFEC5FA2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BEF96C-FEFA-28D9-864B-8F05BA5A32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14B127-EEDD-BD96-6808-616334ABA6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3792E4-4ED5-9039-FF35-9084C9F85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F3D868-A153-DA40-F273-7BEF97381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A0B313-B0DD-E142-A675-BEA8401F3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691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02AEA-28EF-DDB7-7CC6-32E6F21B4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0302E0-2936-A7B5-3BB0-9BBD7D1C5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BB856F-FB4F-19FC-3115-AF4962AD8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FB1390-213A-3CF3-38F6-281A110EB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173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DFC6A5-16C8-E516-83A4-A4DF2F834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C8E1E2-8BEF-758D-B692-B8775869D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B4583A-5CDA-B2C5-0249-55DECBC20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26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7F3884-7F6C-0F57-F8C6-3F070D64B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752C24-424E-5D59-B0D0-C461FC05A0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76E587-C37A-1057-88B2-C8D7AB173B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AB588A-0B02-7D90-75C8-A614C43EE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87D9D9-4C04-35DE-544A-2540EFC7A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E67C09-CD95-2FCE-8622-F683B0CD8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033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36736-C68A-4206-4C7A-AE0122F0C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3BDA7C-E934-C128-A0AC-75A438A010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AC7A02-E330-1B47-4B31-0FD61B5688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392FFE-2B86-BE2B-92B0-6792BD067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A2837C-3BE7-A09A-1D08-385B87419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8F8114-0C67-E460-9FEA-01D5DD743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718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23BE42-6061-8451-1D5C-7682AA0EDE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5232E3-F6C7-12B7-0130-B550759191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713E7-F1E4-2437-96D1-B722BFFA9D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65A2B-5911-4924-B1B8-EE543E913813}" type="datetimeFigureOut">
              <a:rPr lang="en-GB" smtClean="0"/>
              <a:t>25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C5E91C-3373-5CC0-0853-55441B5473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F3956E-3C7E-FF98-37E8-723D3B7D86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14453-BD05-470D-9687-1E8F5BADAEA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360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3ABF45C-953A-421F-4844-8DB790ED5A9D}"/>
              </a:ext>
            </a:extLst>
          </p:cNvPr>
          <p:cNvSpPr txBox="1"/>
          <p:nvPr/>
        </p:nvSpPr>
        <p:spPr>
          <a:xfrm flipH="1">
            <a:off x="594359" y="4918563"/>
            <a:ext cx="11003281" cy="11344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635" algn="just">
              <a:lnSpc>
                <a:spcPct val="107000"/>
              </a:lnSpc>
              <a:spcAft>
                <a:spcPts val="800"/>
              </a:spcAft>
            </a:pPr>
            <a:r>
              <a:rPr lang="en-GB" sz="1600" b="1" dirty="0"/>
              <a:t>Supplementary Figure S1.</a:t>
            </a:r>
            <a:r>
              <a:rPr lang="en-GB" sz="1600" dirty="0"/>
              <a:t> </a:t>
            </a:r>
            <a:r>
              <a:rPr lang="en-US" sz="1600" dirty="0">
                <a:effectLst/>
                <a:ea typeface="Calibri" panose="020F0502020204030204" pitchFamily="34" charset="0"/>
              </a:rPr>
              <a:t>The mean reactivity of array proteins based on the data in Supplementary Table S3, normalized for number of peptides printed, but with tegument Sm25 and esophageal gland MEG-15 removed. The differences in group reactivity were tested for significance using a t-test. All alimentary groups were significantly different from the tegument group (p&lt;0.05). Note the log x- and y-axis scales.</a:t>
            </a:r>
            <a:endParaRPr lang="en-GB" sz="1600" dirty="0">
              <a:effectLst/>
              <a:ea typeface="Calibri" panose="020F0502020204030204" pitchFamily="34" charset="0"/>
            </a:endParaRPr>
          </a:p>
        </p:txBody>
      </p:sp>
      <p:grpSp>
        <p:nvGrpSpPr>
          <p:cNvPr id="17" name="Agrupar 16">
            <a:extLst>
              <a:ext uri="{FF2B5EF4-FFF2-40B4-BE49-F238E27FC236}">
                <a16:creationId xmlns:a16="http://schemas.microsoft.com/office/drawing/2014/main" id="{C4B45FAB-CE35-E680-8F64-283D2377D9F4}"/>
              </a:ext>
            </a:extLst>
          </p:cNvPr>
          <p:cNvGrpSpPr/>
          <p:nvPr/>
        </p:nvGrpSpPr>
        <p:grpSpPr>
          <a:xfrm>
            <a:off x="2379956" y="799784"/>
            <a:ext cx="6540319" cy="4118779"/>
            <a:chOff x="2379956" y="799784"/>
            <a:chExt cx="6540319" cy="4118779"/>
          </a:xfrm>
        </p:grpSpPr>
        <p:pic>
          <p:nvPicPr>
            <p:cNvPr id="15" name="Imagem 14">
              <a:extLst>
                <a:ext uri="{FF2B5EF4-FFF2-40B4-BE49-F238E27FC236}">
                  <a16:creationId xmlns:a16="http://schemas.microsoft.com/office/drawing/2014/main" id="{EFB93036-FEE3-28F3-8291-36B9047744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79956" y="799784"/>
              <a:ext cx="6540319" cy="4118779"/>
            </a:xfrm>
            <a:prstGeom prst="rect">
              <a:avLst/>
            </a:prstGeom>
          </p:spPr>
        </p:pic>
        <p:grpSp>
          <p:nvGrpSpPr>
            <p:cNvPr id="4" name="Agrupar 3">
              <a:extLst>
                <a:ext uri="{FF2B5EF4-FFF2-40B4-BE49-F238E27FC236}">
                  <a16:creationId xmlns:a16="http://schemas.microsoft.com/office/drawing/2014/main" id="{5E86F4E6-5AFE-804A-84BA-FA02B8E2BE15}"/>
                </a:ext>
              </a:extLst>
            </p:cNvPr>
            <p:cNvGrpSpPr/>
            <p:nvPr/>
          </p:nvGrpSpPr>
          <p:grpSpPr>
            <a:xfrm>
              <a:off x="7603498" y="3674935"/>
              <a:ext cx="108000" cy="329204"/>
              <a:chOff x="8074182" y="3309400"/>
              <a:chExt cx="108000" cy="329204"/>
            </a:xfrm>
          </p:grpSpPr>
          <p:cxnSp>
            <p:nvCxnSpPr>
              <p:cNvPr id="5" name="Conector reto 4">
                <a:extLst>
                  <a:ext uri="{FF2B5EF4-FFF2-40B4-BE49-F238E27FC236}">
                    <a16:creationId xmlns:a16="http://schemas.microsoft.com/office/drawing/2014/main" id="{F81FAAA5-E380-BF35-EB44-8BC6E855FA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25259" y="3309400"/>
                <a:ext cx="0" cy="97200"/>
              </a:xfrm>
              <a:prstGeom prst="line">
                <a:avLst/>
              </a:prstGeom>
              <a:ln w="12700">
                <a:solidFill>
                  <a:schemeClr val="tx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Conector reto 5">
                <a:extLst>
                  <a:ext uri="{FF2B5EF4-FFF2-40B4-BE49-F238E27FC236}">
                    <a16:creationId xmlns:a16="http://schemas.microsoft.com/office/drawing/2014/main" id="{92C9F14C-67BD-FC7D-985A-B2EE0BE78C4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8128182" y="3258363"/>
                <a:ext cx="0" cy="108000"/>
              </a:xfrm>
              <a:prstGeom prst="line">
                <a:avLst/>
              </a:prstGeom>
              <a:ln w="12700">
                <a:solidFill>
                  <a:schemeClr val="tx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ector reto 6">
                <a:extLst>
                  <a:ext uri="{FF2B5EF4-FFF2-40B4-BE49-F238E27FC236}">
                    <a16:creationId xmlns:a16="http://schemas.microsoft.com/office/drawing/2014/main" id="{3E24EB23-72AD-11B2-AB0F-6A3EDFAD2E4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8128182" y="3584604"/>
                <a:ext cx="0" cy="108000"/>
              </a:xfrm>
              <a:prstGeom prst="line">
                <a:avLst/>
              </a:prstGeom>
              <a:ln w="12700">
                <a:solidFill>
                  <a:schemeClr val="tx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" name="Conector reto 2">
                <a:extLst>
                  <a:ext uri="{FF2B5EF4-FFF2-40B4-BE49-F238E27FC236}">
                    <a16:creationId xmlns:a16="http://schemas.microsoft.com/office/drawing/2014/main" id="{29E7AA84-80DF-A5A7-3DFE-7431F03D06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25259" y="3554533"/>
                <a:ext cx="0" cy="82800"/>
              </a:xfrm>
              <a:prstGeom prst="line">
                <a:avLst/>
              </a:prstGeom>
              <a:ln w="12700">
                <a:solidFill>
                  <a:schemeClr val="tx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061055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7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Leonardo Paiva Farias</cp:lastModifiedBy>
  <cp:revision>9</cp:revision>
  <dcterms:created xsi:type="dcterms:W3CDTF">2023-09-18T09:50:45Z</dcterms:created>
  <dcterms:modified xsi:type="dcterms:W3CDTF">2023-10-25T19:05:50Z</dcterms:modified>
</cp:coreProperties>
</file>